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311" r:id="rId3"/>
    <p:sldId id="257" r:id="rId4"/>
    <p:sldId id="310" r:id="rId5"/>
    <p:sldId id="258" r:id="rId6"/>
    <p:sldId id="259" r:id="rId7"/>
    <p:sldId id="260" r:id="rId8"/>
    <p:sldId id="261" r:id="rId9"/>
    <p:sldId id="309" r:id="rId10"/>
    <p:sldId id="263" r:id="rId11"/>
    <p:sldId id="264" r:id="rId12"/>
    <p:sldId id="265" r:id="rId13"/>
    <p:sldId id="266" r:id="rId14"/>
    <p:sldId id="267" r:id="rId15"/>
    <p:sldId id="268" r:id="rId16"/>
    <p:sldId id="262" r:id="rId17"/>
    <p:sldId id="269" r:id="rId18"/>
    <p:sldId id="312" r:id="rId19"/>
    <p:sldId id="270" r:id="rId20"/>
    <p:sldId id="271" r:id="rId21"/>
    <p:sldId id="272" r:id="rId22"/>
    <p:sldId id="273" r:id="rId23"/>
    <p:sldId id="274" r:id="rId24"/>
    <p:sldId id="275" r:id="rId25"/>
    <p:sldId id="313" r:id="rId26"/>
    <p:sldId id="276" r:id="rId27"/>
    <p:sldId id="277" r:id="rId28"/>
    <p:sldId id="278" r:id="rId29"/>
    <p:sldId id="279" r:id="rId30"/>
    <p:sldId id="280" r:id="rId31"/>
    <p:sldId id="281" r:id="rId32"/>
    <p:sldId id="282" r:id="rId33"/>
    <p:sldId id="283" r:id="rId34"/>
    <p:sldId id="284" r:id="rId35"/>
    <p:sldId id="314" r:id="rId36"/>
    <p:sldId id="285" r:id="rId37"/>
    <p:sldId id="286" r:id="rId38"/>
    <p:sldId id="287" r:id="rId39"/>
    <p:sldId id="288" r:id="rId40"/>
    <p:sldId id="289" r:id="rId41"/>
    <p:sldId id="290" r:id="rId42"/>
    <p:sldId id="291" r:id="rId43"/>
    <p:sldId id="292" r:id="rId44"/>
    <p:sldId id="293" r:id="rId45"/>
    <p:sldId id="294" r:id="rId46"/>
    <p:sldId id="295" r:id="rId47"/>
    <p:sldId id="296" r:id="rId48"/>
    <p:sldId id="315" r:id="rId49"/>
    <p:sldId id="297" r:id="rId50"/>
    <p:sldId id="298" r:id="rId51"/>
    <p:sldId id="299" r:id="rId52"/>
    <p:sldId id="300" r:id="rId53"/>
    <p:sldId id="301" r:id="rId54"/>
    <p:sldId id="302" r:id="rId55"/>
    <p:sldId id="303" r:id="rId56"/>
    <p:sldId id="316" r:id="rId57"/>
    <p:sldId id="304" r:id="rId58"/>
    <p:sldId id="305" r:id="rId59"/>
    <p:sldId id="306" r:id="rId60"/>
    <p:sldId id="307" r:id="rId61"/>
    <p:sldId id="308" r:id="rId62"/>
    <p:sldId id="317" r:id="rId63"/>
    <p:sldId id="318" r:id="rId64"/>
    <p:sldId id="319" r:id="rId65"/>
    <p:sldId id="320" r:id="rId6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94659"/>
  </p:normalViewPr>
  <p:slideViewPr>
    <p:cSldViewPr snapToGrid="0" snapToObjects="1">
      <p:cViewPr varScale="1">
        <p:scale>
          <a:sx n="84" d="100"/>
          <a:sy n="84" d="100"/>
        </p:scale>
        <p:origin x="44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viewProps" Target="view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slide" Target="slides/slide60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theme" Target="theme/theme1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presProps" Target="presProps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55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14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5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27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105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252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681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76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271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725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FC93E-B3D5-7648-BD22-DB5F9A69322E}" type="datetimeFigureOut">
              <a:rPr lang="en-US" smtClean="0"/>
              <a:t>1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708CE-739F-2C46-998E-9FA96704F5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1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0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3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0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3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3.png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6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0.png"/><Relationship Id="rId4" Type="http://schemas.openxmlformats.org/officeDocument/2006/relationships/image" Target="../media/image51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4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7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3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6.pn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9.png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3.png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6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5.png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7.png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0.png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png"/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5.png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8.png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1.png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4.png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7.png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png"/><Relationship Id="rId1" Type="http://schemas.openxmlformats.org/officeDocument/2006/relationships/slideLayout" Target="../slideLayouts/slideLayout6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png"/><Relationship Id="rId2" Type="http://schemas.openxmlformats.org/officeDocument/2006/relationships/image" Target="../media/image99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3.png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101.png"/><Relationship Id="rId1" Type="http://schemas.openxmlformats.org/officeDocument/2006/relationships/slideLayout" Target="../slideLayouts/slideLayout6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png"/><Relationship Id="rId2" Type="http://schemas.openxmlformats.org/officeDocument/2006/relationships/image" Target="../media/image10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.png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png"/><Relationship Id="rId2" Type="http://schemas.openxmlformats.org/officeDocument/2006/relationships/image" Target="../media/image105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7.png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9.png"/><Relationship Id="rId2" Type="http://schemas.openxmlformats.org/officeDocument/2006/relationships/image" Target="../media/image108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0.png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2.png"/><Relationship Id="rId2" Type="http://schemas.openxmlformats.org/officeDocument/2006/relationships/image" Target="../media/image11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3.png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5.png"/><Relationship Id="rId2" Type="http://schemas.openxmlformats.org/officeDocument/2006/relationships/image" Target="../media/image114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17.png"/><Relationship Id="rId4" Type="http://schemas.openxmlformats.org/officeDocument/2006/relationships/image" Target="../media/image116.png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9.png"/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3.png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6.xml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2.png"/><Relationship Id="rId2" Type="http://schemas.openxmlformats.org/officeDocument/2006/relationships/image" Target="../media/image12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3.png"/></Relationships>
</file>

<file path=ppt/slides/_rels/slide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5.png"/><Relationship Id="rId2" Type="http://schemas.openxmlformats.org/officeDocument/2006/relationships/image" Target="../media/image12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6.png"/></Relationships>
</file>

<file path=ppt/slides/_rels/slide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8.png"/><Relationship Id="rId2" Type="http://schemas.openxmlformats.org/officeDocument/2006/relationships/image" Target="../media/image12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.png"/></Relationships>
</file>

<file path=ppt/slides/_rels/slide6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1.png"/><Relationship Id="rId2" Type="http://schemas.openxmlformats.org/officeDocument/2006/relationships/image" Target="../media/image130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6.png"/></Relationships>
</file>

<file path=ppt/slides/_rels/slide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2.png"/><Relationship Id="rId2" Type="http://schemas.openxmlformats.org/officeDocument/2006/relationships/image" Target="../media/image11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33.png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3.png"/></Relationships>
</file>

<file path=ppt/slides/_rels/slide6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6.png"/></Relationships>
</file>

<file path=ppt/slides/_rels/slide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rvey Question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Healthy Pregnancy Stud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1596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alth Histor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6758" y="1597305"/>
            <a:ext cx="2645883" cy="465430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2638" y="1597305"/>
            <a:ext cx="2685852" cy="465431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5956" y="1597305"/>
            <a:ext cx="2642039" cy="47753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824745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alth History Cont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0516" y="1563367"/>
            <a:ext cx="2923721" cy="51165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7563" y="1342662"/>
            <a:ext cx="2881924" cy="508128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124325" y="2959975"/>
            <a:ext cx="19716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chemeClr val="accent2"/>
                </a:solidFill>
              </a:rPr>
              <a:t>If no, skip to prenatal vitamins question.  </a:t>
            </a:r>
            <a:endParaRPr lang="en-US" sz="1200" b="1" dirty="0">
              <a:solidFill>
                <a:schemeClr val="accent2"/>
              </a:solidFill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4124325" y="2643188"/>
            <a:ext cx="29051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920877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alth History Cont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597307"/>
            <a:ext cx="2758988" cy="484175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5664" y="1690688"/>
            <a:ext cx="2703194" cy="474837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6656" y="1690687"/>
            <a:ext cx="2607144" cy="457545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25488" y="3470580"/>
            <a:ext cx="117483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If carrying more than one baby skip to What is the sex of baby one</a:t>
            </a:r>
            <a:endParaRPr lang="en-US" sz="12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07412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alth History Cont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5240" y="1863524"/>
            <a:ext cx="2507585" cy="443776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5064" y="1690688"/>
            <a:ext cx="2603675" cy="458006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52574" y="1610569"/>
            <a:ext cx="2810382" cy="4943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00421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alth History Cont. 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534" y="1469983"/>
            <a:ext cx="2815555" cy="498065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1848" y="1469983"/>
            <a:ext cx="2781099" cy="48308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631680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alth History Cont. 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9779" y="1690686"/>
            <a:ext cx="2705358" cy="477678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95882" y="1612085"/>
            <a:ext cx="2757918" cy="477678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8046" y="1533484"/>
            <a:ext cx="2811443" cy="493399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786188" y="3128963"/>
            <a:ext cx="15935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accent2"/>
                </a:solidFill>
              </a:rPr>
              <a:t>Top of screen left, bottom of screen right</a:t>
            </a:r>
            <a:endParaRPr lang="en-US" sz="12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3966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Questions for Participants Before 25 Weeks of Pregnanc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ese questions will be asked at the following intervals: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5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9 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13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17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21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25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29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436619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renatal Visit Prior to Week 25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463" y="1386682"/>
            <a:ext cx="2677111" cy="467836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487" y="1300560"/>
            <a:ext cx="2910396" cy="51292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034463" y="3371850"/>
            <a:ext cx="19944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If yes, continue to weight question. If no, continue to miscarriage question.</a:t>
            </a:r>
            <a:endParaRPr lang="en-US" sz="1200" dirty="0">
              <a:solidFill>
                <a:schemeClr val="accent2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143499" y="4018181"/>
            <a:ext cx="15716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If yes, survey ends.</a:t>
            </a:r>
          </a:p>
          <a:p>
            <a:r>
              <a:rPr lang="en-US" sz="1200" dirty="0" smtClean="0">
                <a:solidFill>
                  <a:schemeClr val="accent2"/>
                </a:solidFill>
              </a:rPr>
              <a:t>If no, next question.</a:t>
            </a:r>
            <a:endParaRPr lang="en-US" sz="1200" dirty="0">
              <a:solidFill>
                <a:schemeClr val="accent2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1139" y="1300560"/>
            <a:ext cx="2912661" cy="516731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9458325" y="4214812"/>
            <a:ext cx="1300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Survey and study end for these participants.</a:t>
            </a:r>
            <a:endParaRPr lang="en-US" sz="12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581250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renatal Visit Prior to Week 2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452156"/>
            <a:ext cx="2908636" cy="51165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2308" y="1452156"/>
            <a:ext cx="2838691" cy="503394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096000" y="4457880"/>
            <a:ext cx="1300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Survey &amp; study end for these participants.</a:t>
            </a:r>
            <a:endParaRPr lang="en-US" sz="12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5884127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rior to Week 2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408" y="1504951"/>
            <a:ext cx="2952892" cy="51292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0661" y="1504950"/>
            <a:ext cx="2886040" cy="506955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2550" y="1481473"/>
            <a:ext cx="2855930" cy="4990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1365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rvey Typ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Short Intake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Health History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Before 25 Weeks Post-Prenatal Visit Questions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25-41 Weeks Post Prenatal Visit Questions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wins Questions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ly Before 25 Weeks Questions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ly 25-41 Weeks Questio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453988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rior to Week 25 Cont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556" y="1690688"/>
            <a:ext cx="2714643" cy="48482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5776" y="1462088"/>
            <a:ext cx="2821399" cy="494672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7788" y="1600507"/>
            <a:ext cx="2735261" cy="4938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30644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rior to Week 2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3781" y="1514474"/>
            <a:ext cx="2847655" cy="49625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8414" y="1343023"/>
            <a:ext cx="2955172" cy="530542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68078" y="1184272"/>
            <a:ext cx="3081303" cy="54641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379332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rior to Week 25 </a:t>
            </a:r>
            <a:r>
              <a:rPr lang="en-US" dirty="0" err="1" smtClean="0"/>
              <a:t>cont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4333" y="1485899"/>
            <a:ext cx="2821379" cy="48799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2014" y="1485899"/>
            <a:ext cx="2813336" cy="5092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07419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Questions for Week 25 and Beyond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e following questions will be asked during the following weeks of pregnancy: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29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31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33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35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37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38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39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40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ek 4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63744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 Questions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8295" y="1690688"/>
            <a:ext cx="2732484" cy="492918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8134" y="1690688"/>
            <a:ext cx="2893695" cy="51673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33708" y="4586288"/>
            <a:ext cx="32416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Yes, takes participant to date of last prenatal visit</a:t>
            </a:r>
          </a:p>
          <a:p>
            <a:r>
              <a:rPr lang="en-US" sz="1200" dirty="0" smtClean="0">
                <a:solidFill>
                  <a:schemeClr val="accent2"/>
                </a:solidFill>
              </a:rPr>
              <a:t>No, takes participant to Birth Date screen</a:t>
            </a:r>
          </a:p>
          <a:p>
            <a:r>
              <a:rPr lang="en-US" sz="1200" dirty="0" smtClean="0">
                <a:solidFill>
                  <a:schemeClr val="accent2"/>
                </a:solidFill>
              </a:rPr>
              <a:t>No ended goes to the next screen on this page</a:t>
            </a:r>
            <a:endParaRPr lang="en-US" sz="1200" dirty="0">
              <a:solidFill>
                <a:schemeClr val="accent2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3999" y="1590675"/>
            <a:ext cx="2891185" cy="51292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9769184" y="4435636"/>
            <a:ext cx="14001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Survey &amp; Study </a:t>
            </a:r>
            <a:r>
              <a:rPr lang="en-US" sz="1200" smtClean="0">
                <a:solidFill>
                  <a:schemeClr val="accent2"/>
                </a:solidFill>
              </a:rPr>
              <a:t>ends for these participant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904581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 Question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471" y="1947484"/>
            <a:ext cx="2467297" cy="4483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974432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 Question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734" y="1690688"/>
            <a:ext cx="2657527" cy="46958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7759" y="1690688"/>
            <a:ext cx="2598241" cy="46958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8594" y="1717072"/>
            <a:ext cx="2580928" cy="466944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159" y="1506236"/>
            <a:ext cx="2819841" cy="5091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021756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 Question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1953" y="1690688"/>
            <a:ext cx="2429185" cy="451485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9163" y="1549338"/>
            <a:ext cx="2919458" cy="51943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7185" y="1364457"/>
            <a:ext cx="2936615" cy="516731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674355" y="4414838"/>
            <a:ext cx="18410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None selected, user is taken to vaccines question on next slide.  </a:t>
            </a:r>
            <a:endParaRPr lang="en-US" sz="12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025652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32" y="1557337"/>
            <a:ext cx="2734472" cy="49149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3186" y="1602582"/>
            <a:ext cx="2760366" cy="495776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4516" y="1304926"/>
            <a:ext cx="2937693" cy="5255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367733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7890" y="1690688"/>
            <a:ext cx="2726859" cy="475615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0637" y="1571625"/>
            <a:ext cx="2854325" cy="507018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86767" y="1582592"/>
            <a:ext cx="2901280" cy="51673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18786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hort Intake – Just After Registering</a:t>
            </a: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4294967295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779789"/>
            <a:ext cx="2533650" cy="4351337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1172" y="1779788"/>
            <a:ext cx="2729054" cy="477805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1507" y="1779788"/>
            <a:ext cx="2766540" cy="48301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474210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690688"/>
            <a:ext cx="2519847" cy="452913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296" y="1562101"/>
            <a:ext cx="2650030" cy="474580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6575" y="1403326"/>
            <a:ext cx="2738437" cy="5063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953606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690688"/>
            <a:ext cx="2750291" cy="49577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0137" y="1376362"/>
            <a:ext cx="2631726" cy="46958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3509" y="1162049"/>
            <a:ext cx="2859294" cy="5124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040371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5 Weeks &amp; Beyond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723" y="1557336"/>
            <a:ext cx="2824232" cy="50577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2101" y="1416284"/>
            <a:ext cx="2948874" cy="519882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38959" y="1294839"/>
            <a:ext cx="3045364" cy="54417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534462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/ Multiples Survey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is survey will begin appearing when a participant indicates they are having more than one baby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51031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8702" y="1557337"/>
            <a:ext cx="2625295" cy="464343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6444" y="1390672"/>
            <a:ext cx="2830512" cy="511011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4007" y="1231117"/>
            <a:ext cx="3060295" cy="54292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506568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780" y="1517994"/>
            <a:ext cx="2797683" cy="499586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8137" y="1500440"/>
            <a:ext cx="2827115" cy="5013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92802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3595" y="1471612"/>
            <a:ext cx="2797666" cy="51149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746" y="1471612"/>
            <a:ext cx="3030867" cy="526935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1098" y="1342230"/>
            <a:ext cx="2936551" cy="5373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623100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0010" y="1490663"/>
            <a:ext cx="2860639" cy="51165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2434" y="1490663"/>
            <a:ext cx="2867131" cy="517649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1354" y="1539081"/>
            <a:ext cx="2805388" cy="5019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222513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7483" y="1547813"/>
            <a:ext cx="2881580" cy="51292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3635" y="1573213"/>
            <a:ext cx="2921956" cy="51038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45852" y="1573213"/>
            <a:ext cx="2852764" cy="5129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3178593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452" y="1690688"/>
            <a:ext cx="2637848" cy="45815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4378" y="1690688"/>
            <a:ext cx="2775359" cy="4975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37729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hort Intak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is is a quick survey after participants finish the consent process. All participants take this survey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718908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0154" y="1613694"/>
            <a:ext cx="2711692" cy="48307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519238"/>
            <a:ext cx="2895243" cy="50196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86826" y="1560116"/>
            <a:ext cx="2786062" cy="5014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3207463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462088"/>
            <a:ext cx="2897122" cy="5141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8907" y="1589088"/>
            <a:ext cx="2942956" cy="51165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4293" y="1537494"/>
            <a:ext cx="2929482" cy="5078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967244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118" y="1533526"/>
            <a:ext cx="2916081" cy="50911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4807" y="1533526"/>
            <a:ext cx="2931568" cy="51038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97220" y="1442245"/>
            <a:ext cx="3013528" cy="5273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3275630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443037"/>
            <a:ext cx="2817749" cy="491013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0146" y="1567657"/>
            <a:ext cx="2887529" cy="51419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1872" y="1457325"/>
            <a:ext cx="2900790" cy="5129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7979242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690688"/>
            <a:ext cx="2559068" cy="45513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0511" y="1690688"/>
            <a:ext cx="2658875" cy="46926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4023" y="1690688"/>
            <a:ext cx="2920001" cy="5129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1823898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wins Multiples Survey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9896" y="1500186"/>
            <a:ext cx="2769015" cy="4905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7798419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 Flow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Participants have the option to enter their information weekly. If they have not had a prenatal visit we rephrase certain questions and do not ask other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257589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Before 25 Weeks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1" y="1515146"/>
            <a:ext cx="2694590" cy="484142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5937" y="1471838"/>
            <a:ext cx="2900118" cy="51673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514474" y="3857624"/>
            <a:ext cx="16287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Yes, skips to weight question. No continues to miscarriage question.</a:t>
            </a:r>
            <a:endParaRPr lang="en-US" sz="1200" dirty="0">
              <a:solidFill>
                <a:schemeClr val="accent2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329363" y="3714750"/>
            <a:ext cx="126162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Selecting yes, survey ends. No continues to next question. </a:t>
            </a:r>
            <a:endParaRPr lang="en-US" sz="1200" dirty="0">
              <a:solidFill>
                <a:schemeClr val="accent2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8699" y="1381463"/>
            <a:ext cx="3014544" cy="53480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3214824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eekly Questions Before 25 Week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9376" y="1426905"/>
            <a:ext cx="2805112" cy="512400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01840" y="4408688"/>
            <a:ext cx="14716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Survey ends after this question.</a:t>
            </a:r>
            <a:endParaRPr lang="en-US" sz="1200" dirty="0">
              <a:solidFill>
                <a:schemeClr val="accent2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450" y="1434397"/>
            <a:ext cx="2885251" cy="5116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1623369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Before 25 Week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500187"/>
            <a:ext cx="2617326" cy="473233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5011" y="1473200"/>
            <a:ext cx="2786642" cy="49768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6800" y="1473200"/>
            <a:ext cx="2667000" cy="4795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43543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hort Intak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041" y="1690688"/>
            <a:ext cx="2798452" cy="491345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0202" y="1314119"/>
            <a:ext cx="3077280" cy="544363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5464" y="1331088"/>
            <a:ext cx="2892501" cy="5050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2616699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Before 25 Week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988" y="1457324"/>
            <a:ext cx="2684012" cy="473233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8578" y="1506537"/>
            <a:ext cx="2787872" cy="48672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58213" y="1506537"/>
            <a:ext cx="2795587" cy="4938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5967644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Before 25 Week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629570"/>
            <a:ext cx="2877936" cy="5141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0706" y="1690688"/>
            <a:ext cx="2867043" cy="50196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3010" y="1690688"/>
            <a:ext cx="2900790" cy="5129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115028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Before 2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974" y="1519251"/>
            <a:ext cx="2968625" cy="511966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8520" y="1519251"/>
            <a:ext cx="2942956" cy="51165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8397" y="1519251"/>
            <a:ext cx="2699923" cy="4776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7419511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Before 2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164" y="1690688"/>
            <a:ext cx="2737347" cy="48037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7991" y="1690688"/>
            <a:ext cx="2633933" cy="46640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8657" y="1690688"/>
            <a:ext cx="2821859" cy="507184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7662" y="1690688"/>
            <a:ext cx="2733183" cy="48037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343026" y="2900363"/>
            <a:ext cx="12573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Selecting no, survey ends.</a:t>
            </a:r>
            <a:endParaRPr lang="en-US" sz="12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3516596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25-41 Week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is set of questions will appear for participants who’ve signed up to enter data weekly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50602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Weeks 25-41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443038"/>
            <a:ext cx="2971505" cy="533474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2025" y="1443038"/>
            <a:ext cx="2957512" cy="528408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432459" y="3471863"/>
            <a:ext cx="12252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Yes continues to 3</a:t>
            </a:r>
            <a:r>
              <a:rPr lang="en-US" sz="1200" baseline="30000" dirty="0" smtClean="0">
                <a:solidFill>
                  <a:schemeClr val="accent2"/>
                </a:solidFill>
              </a:rPr>
              <a:t>rd</a:t>
            </a:r>
            <a:r>
              <a:rPr lang="en-US" sz="1200" dirty="0" smtClean="0">
                <a:solidFill>
                  <a:schemeClr val="accent2"/>
                </a:solidFill>
              </a:rPr>
              <a:t> question on this screen.</a:t>
            </a:r>
          </a:p>
          <a:p>
            <a:r>
              <a:rPr lang="en-US" sz="1200" dirty="0" smtClean="0">
                <a:solidFill>
                  <a:schemeClr val="accent2"/>
                </a:solidFill>
              </a:rPr>
              <a:t>No I gave birth skips to Birth date question</a:t>
            </a:r>
          </a:p>
          <a:p>
            <a:r>
              <a:rPr lang="en-US" sz="1200" dirty="0" smtClean="0">
                <a:solidFill>
                  <a:schemeClr val="accent2"/>
                </a:solidFill>
              </a:rPr>
              <a:t>No pregnancy ended goes to next question. </a:t>
            </a:r>
            <a:endParaRPr lang="en-US" sz="1200" dirty="0">
              <a:solidFill>
                <a:schemeClr val="accent2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80434" y="3471863"/>
            <a:ext cx="971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Survey ends after this question.</a:t>
            </a:r>
            <a:endParaRPr lang="en-US" sz="1200" dirty="0">
              <a:solidFill>
                <a:schemeClr val="accent2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91857" y="1443038"/>
            <a:ext cx="2891185" cy="5129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4376887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Weeks 25-4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3722" y="1299109"/>
            <a:ext cx="3076007" cy="54627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20026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Weeks 25-4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287" y="1519067"/>
            <a:ext cx="2738437" cy="477219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2062" y="1514389"/>
            <a:ext cx="2865161" cy="495317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3561" y="1424697"/>
            <a:ext cx="3013646" cy="5313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0160122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Weeks 25-4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1159" y="1485900"/>
            <a:ext cx="2753916" cy="489585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7224" y="1485900"/>
            <a:ext cx="2830511" cy="508355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89884" y="1419226"/>
            <a:ext cx="2930641" cy="52339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3769849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Weeks 25-4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543049"/>
            <a:ext cx="2711598" cy="48609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7750" y="1452459"/>
            <a:ext cx="2998787" cy="528499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4320" y="1543049"/>
            <a:ext cx="2898580" cy="51038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13478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hort Intak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4577" y="1516284"/>
            <a:ext cx="2685017" cy="463935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4235" y="1144206"/>
            <a:ext cx="3025697" cy="538351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6909" y="1422059"/>
            <a:ext cx="2943049" cy="5002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9299010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Weeks 25-4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0798" y="1590675"/>
            <a:ext cx="2841440" cy="51165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7776" y="1590674"/>
            <a:ext cx="2955924" cy="52169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2657" y="1515268"/>
            <a:ext cx="2930619" cy="526732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842250" y="2357438"/>
            <a:ext cx="11255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No, ends survey. Yes, continues to next question</a:t>
            </a:r>
            <a:endParaRPr lang="en-US" sz="12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5636289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eekly Questions Weeks 25-4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9718" y="1533525"/>
            <a:ext cx="2874990" cy="50530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2825" y="1561307"/>
            <a:ext cx="2883900" cy="515461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0701" y="1593057"/>
            <a:ext cx="2857158" cy="509111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606134" y="4886326"/>
            <a:ext cx="23717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accent2"/>
                </a:solidFill>
              </a:rPr>
              <a:t>Refer to the baby born flow above for questions following this on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2017689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utcomes Survey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We will remind users who have not submitted outcomes 4 weeks after their due date to come in and complete the outcomes survey if they have not already recorded the birth in a previous survey. 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Notification Message:</a:t>
            </a: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Healthy Pregnancy Study: You’re almost finished! Answer 7 easy questions to complete your participation in the study. </a:t>
            </a:r>
          </a:p>
        </p:txBody>
      </p:sp>
    </p:spTree>
    <p:extLst>
      <p:ext uri="{BB962C8B-B14F-4D97-AF65-F5344CB8AC3E}">
        <p14:creationId xmlns:p14="http://schemas.microsoft.com/office/powerpoint/2010/main" val="277536708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utcomes Survey 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690688"/>
            <a:ext cx="2519847" cy="452913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296" y="1562101"/>
            <a:ext cx="2650030" cy="474580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6575" y="1403326"/>
            <a:ext cx="2738437" cy="5063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6956329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utcomes Cont. 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509712"/>
            <a:ext cx="2750291" cy="49577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0137" y="1640681"/>
            <a:ext cx="2631726" cy="46958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3509" y="1343024"/>
            <a:ext cx="2859294" cy="5124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3929460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utcomes Cont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574" y="1522612"/>
            <a:ext cx="2824232" cy="50577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8952" y="1381560"/>
            <a:ext cx="2948874" cy="519882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5810" y="1260115"/>
            <a:ext cx="3045364" cy="54417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1773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hort Intak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3939" y="1539432"/>
            <a:ext cx="2833898" cy="500154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923" y="1305527"/>
            <a:ext cx="2989387" cy="519156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9397" y="1261641"/>
            <a:ext cx="2984403" cy="5279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53818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hort Intake Cont.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8278" y="1493134"/>
            <a:ext cx="2840168" cy="493097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015" y="1389284"/>
            <a:ext cx="2877273" cy="5138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94848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ealth Histor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Health History questions are assigned two days after a participant enrolls in the study. All participants receive the same set of question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58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90</TotalTime>
  <Words>715</Words>
  <Application>Microsoft Office PowerPoint</Application>
  <PresentationFormat>Widescreen</PresentationFormat>
  <Paragraphs>123</Paragraphs>
  <Slides>6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5</vt:i4>
      </vt:variant>
    </vt:vector>
  </HeadingPairs>
  <TitlesOfParts>
    <vt:vector size="69" baseType="lpstr">
      <vt:lpstr>Arial</vt:lpstr>
      <vt:lpstr>Calibri</vt:lpstr>
      <vt:lpstr>Calibri Light</vt:lpstr>
      <vt:lpstr>Office Theme</vt:lpstr>
      <vt:lpstr>Survey Questions</vt:lpstr>
      <vt:lpstr>Survey Types</vt:lpstr>
      <vt:lpstr>Short Intake – Just After Registering</vt:lpstr>
      <vt:lpstr>Short Intake</vt:lpstr>
      <vt:lpstr>Short Intake</vt:lpstr>
      <vt:lpstr>Short Intake</vt:lpstr>
      <vt:lpstr>Short Intake</vt:lpstr>
      <vt:lpstr>Short Intake Cont.</vt:lpstr>
      <vt:lpstr>Health History</vt:lpstr>
      <vt:lpstr>Health History</vt:lpstr>
      <vt:lpstr>Health History Cont.</vt:lpstr>
      <vt:lpstr>Health History Cont.</vt:lpstr>
      <vt:lpstr>Health History Cont.</vt:lpstr>
      <vt:lpstr>Health History Cont. </vt:lpstr>
      <vt:lpstr>Health History Cont. </vt:lpstr>
      <vt:lpstr>Questions for Participants Before 25 Weeks of Pregnancy</vt:lpstr>
      <vt:lpstr>Prenatal Visit Prior to Week 25</vt:lpstr>
      <vt:lpstr>Prenatal Visit Prior to Week 25</vt:lpstr>
      <vt:lpstr>Prior to Week 25</vt:lpstr>
      <vt:lpstr>Prior to Week 25 Cont.</vt:lpstr>
      <vt:lpstr>Prior to Week 25</vt:lpstr>
      <vt:lpstr>Prior to Week 25 cont</vt:lpstr>
      <vt:lpstr>Questions for Week 25 and Beyond</vt:lpstr>
      <vt:lpstr>25 Weeks &amp; Beyond Questions</vt:lpstr>
      <vt:lpstr>25 Weeks &amp; Beyond Questions</vt:lpstr>
      <vt:lpstr>25 Weeks &amp; Beyond Questions</vt:lpstr>
      <vt:lpstr>25 Weeks &amp; Beyond Questions</vt:lpstr>
      <vt:lpstr>25 Weeks &amp; Beyond</vt:lpstr>
      <vt:lpstr>25 Weeks &amp; Beyond</vt:lpstr>
      <vt:lpstr>25 Weeks &amp; Beyond</vt:lpstr>
      <vt:lpstr>25 Weeks &amp; Beyond</vt:lpstr>
      <vt:lpstr>25 Weeks &amp; Beyond</vt:lpstr>
      <vt:lpstr>Twins /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Twins Multiples Survey</vt:lpstr>
      <vt:lpstr>Weekly Question Flow</vt:lpstr>
      <vt:lpstr>Weekly Questions Before 25 Weeks</vt:lpstr>
      <vt:lpstr>Weekly Questions Before 25 Weeks</vt:lpstr>
      <vt:lpstr>Weekly Questions Before 25 Weeks</vt:lpstr>
      <vt:lpstr>Weekly Questions Before 25 Weeks</vt:lpstr>
      <vt:lpstr>Weekly Questions Before 25 Weeks</vt:lpstr>
      <vt:lpstr>Weekly Questions Before 25</vt:lpstr>
      <vt:lpstr>Weekly Questions Before 25</vt:lpstr>
      <vt:lpstr>Weekly Questions 25-41 Weeks</vt:lpstr>
      <vt:lpstr>Weekly Questions Weeks 25-41</vt:lpstr>
      <vt:lpstr>Weekly Questions Weeks 25-41</vt:lpstr>
      <vt:lpstr>Weekly Questions Weeks 25-41</vt:lpstr>
      <vt:lpstr>Weekly Questions Weeks 25-41</vt:lpstr>
      <vt:lpstr>Weekly Questions Weeks 25-41</vt:lpstr>
      <vt:lpstr>Weekly Questions Weeks 25-41</vt:lpstr>
      <vt:lpstr>Weekly Questions Weeks 25-41</vt:lpstr>
      <vt:lpstr>Outcomes Survey</vt:lpstr>
      <vt:lpstr>Outcomes Survey </vt:lpstr>
      <vt:lpstr>Outcomes Cont. </vt:lpstr>
      <vt:lpstr>Outcomes Cont.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rvey Questions</dc:title>
  <dc:creator>Microsoft Office User</dc:creator>
  <cp:lastModifiedBy>Ebner, Gail</cp:lastModifiedBy>
  <cp:revision>19</cp:revision>
  <dcterms:created xsi:type="dcterms:W3CDTF">2016-12-27T15:56:15Z</dcterms:created>
  <dcterms:modified xsi:type="dcterms:W3CDTF">2017-01-12T17:49:21Z</dcterms:modified>
</cp:coreProperties>
</file>